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485" autoAdjust="0"/>
    <p:restoredTop sz="94660"/>
  </p:normalViewPr>
  <p:slideViewPr>
    <p:cSldViewPr snapToGrid="0">
      <p:cViewPr>
        <p:scale>
          <a:sx n="80" d="100"/>
          <a:sy n="80" d="100"/>
        </p:scale>
        <p:origin x="1804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24E7B00-40FF-4460-A117-4DD3C37AB8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462B5BB5-525B-4760-802E-ED3514113A6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en-US"/>
              <a:t>Click to edit Master subtitle style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0B93C94-6D2A-4F88-BA25-D9D1A39BE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7BE5977-42A2-4B27-8DC7-7BC7CF2BF6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7692A5D-DEB6-49B1-B80F-6438DC3A24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187301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6A05B2F-B517-49E0-BC5C-9C553191B0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5E90FB7B-F9B5-45F0-B9D6-04AAC54A94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52AC846-32E5-464F-AC4A-67F5480700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F805C89-B546-4EB1-BC6D-EF8751E4A9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22BF9AB8-4BCF-43B2-A722-A6F01B8A00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4993002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9D17B43E-66DF-4907-A14E-AD50204ADCF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E4BF6B7-BAC4-4625-B664-84B5E5A467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85CAC0D-135A-449A-9E00-C47AED6A6E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5611F06B-C48C-4D2E-84E8-DB384C4FE7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781CE8B-299F-47A4-83A4-8E31E8612E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131454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6B574F1-3AAE-478D-AB85-CEC7B14E75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A3BA82B-23A4-490D-BDF9-7F1E6410043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D416BAF2-397A-4E2F-848B-A3CBBAE698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ADDC0078-A37D-4936-A3EA-CDDB1A4D7F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879A5E0-7BFE-4836-BC9E-F772FB2C2B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3794954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82DD1D2-8F8F-4608-8716-E394A75F9F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C8A2AE6E-6025-476E-A01B-02AC620595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12E08C8-E6CA-4B59-A7B6-CC80AEEA4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79CFA00-3192-41EE-9F04-7CD8BBBD12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FA78A79-7F08-401E-907D-1C2B7338D9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2861236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C8C147D-B6F1-4147-AD7D-9966D2B543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899ED6EF-626A-4749-96A4-185D050D3B2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B5754D9A-88C5-4E6F-A413-9561C73D99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1253F59-2C30-449E-8287-7FE6A11C4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37F8C9E3-BBB7-4276-B0FC-9201D147DB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1EB3E01-FDC9-4374-94BE-20F186725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321848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B96B3E5-850F-46BE-8228-969249826C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35CE3F11-E2CD-4F7A-8BD6-C8FF8FAE57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69802920-1CF3-4367-BED9-13F2938F0F5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98B44C78-66F0-42C9-9134-293FD8C81F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7F892756-1C81-41DF-AA14-80DE0656EA2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6AC6AB90-1458-4160-822F-0367F9D9D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A9225554-8A6F-40D5-9172-F48FEEB140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1ED91FE9-30BD-4773-8B02-4912797587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50584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B7D4DB2-0B47-4FDB-993D-2C38AD222D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B2E1BF3E-D4D7-484A-9107-AD20B9554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13287729-EC90-40D9-9448-8333132D7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578D7B7F-741F-4620-BE69-A025E6F930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6443062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37E4F60A-A84E-4A27-B1C3-5D969F0627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7FCA4CDE-9A73-4812-B2DF-D6D247A06E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15F07BBF-E000-4C78-B08D-BE7F4DDC1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4076536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CBC17F0-F453-46D9-8A0B-9D4A738C9F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0425C148-D9A7-4E17-8CB6-34087285002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79393348-0E8F-4C13-832E-3B47A639E3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C1CA5E0-0DF4-4D08-A049-E0434149AA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71A1F904-D52C-40A3-A205-08F8826BC4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F4DA947-18DF-46AD-8BA2-4CF70B7F7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755376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9FD01B1-B052-4F48-BCB0-7EC450B35A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CA6ECABA-D4D1-4CB1-89C2-33C8D8481C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endParaRPr lang="en-NZ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8BBF749-6416-4536-A8D2-8DAE894968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259CA8F-A76E-4F89-87E8-9A06D4A55D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1DF2EF06-0184-4A21-A53C-2AFEE2B6D5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Z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104B78A-E488-489B-B173-2C68BAD6F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2947212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BD6CDFF7-9B86-48C1-AE49-9B0D9F2B49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NZ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BB00AE44-2CC3-467F-B7AE-37CEC0BC83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NZ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A3393F6-496F-4473-B283-F28CDFF7563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E847AD-B169-4AD2-A7B8-659AAB2A1ABA}" type="datetimeFigureOut">
              <a:rPr lang="en-NZ" smtClean="0"/>
              <a:t>8/01/2020</a:t>
            </a:fld>
            <a:endParaRPr lang="en-NZ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D153093-2125-469E-9E51-DE2A5E4521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Z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A8B2825-DE93-4800-AE8B-8EA3B88CE17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FD3E58-4BCB-40A6-85B1-AF6428A8C3CB}" type="slidenum">
              <a:rPr lang="en-NZ" smtClean="0"/>
              <a:t>‹#›</a:t>
            </a:fld>
            <a:endParaRPr lang="en-NZ"/>
          </a:p>
        </p:txBody>
      </p:sp>
    </p:spTree>
    <p:extLst>
      <p:ext uri="{BB962C8B-B14F-4D97-AF65-F5344CB8AC3E}">
        <p14:creationId xmlns:p14="http://schemas.microsoft.com/office/powerpoint/2010/main" val="14316742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Box 70">
            <a:extLst>
              <a:ext uri="{FF2B5EF4-FFF2-40B4-BE49-F238E27FC236}">
                <a16:creationId xmlns:a16="http://schemas.microsoft.com/office/drawing/2014/main" xmlns="" id="{F27E6A6E-AC55-49C2-BAA2-FAB4A2276449}"/>
              </a:ext>
            </a:extLst>
          </p:cNvPr>
          <p:cNvSpPr txBox="1"/>
          <p:nvPr/>
        </p:nvSpPr>
        <p:spPr>
          <a:xfrm>
            <a:off x="739140" y="7751606"/>
            <a:ext cx="1167576" cy="1107996"/>
          </a:xfrm>
          <a:prstGeom prst="rect">
            <a:avLst/>
          </a:prstGeom>
          <a:noFill/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ingle-dose period 1</a:t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ay 1</a:t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fter breakfast</a:t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low-fat meal)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xmlns="" id="{0E4D376D-1020-4EFE-A723-61E81E578F7E}"/>
              </a:ext>
            </a:extLst>
          </p:cNvPr>
          <p:cNvSpPr txBox="1"/>
          <p:nvPr/>
        </p:nvSpPr>
        <p:spPr>
          <a:xfrm>
            <a:off x="2487296" y="7756109"/>
            <a:ext cx="1245234" cy="1107996"/>
          </a:xfrm>
          <a:prstGeom prst="rect">
            <a:avLst/>
          </a:prstGeom>
          <a:noFill/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ingle-dose period 2</a:t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ay 4</a:t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fter breakfast</a:t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high-fat meal)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xmlns="" id="{F6797F6B-4B34-4149-AD7B-1050C85F9C94}"/>
              </a:ext>
            </a:extLst>
          </p:cNvPr>
          <p:cNvSpPr txBox="1"/>
          <p:nvPr/>
        </p:nvSpPr>
        <p:spPr>
          <a:xfrm>
            <a:off x="4313705" y="7756042"/>
            <a:ext cx="1315885" cy="1277273"/>
          </a:xfrm>
          <a:prstGeom prst="rect">
            <a:avLst/>
          </a:prstGeom>
          <a:noFill/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Repeated-dose period</a:t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ays 7–12</a:t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After breakfast and dinner</a:t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(ordinary meal)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xmlns="" id="{19228916-3BC2-4961-B93C-AD96497BD79C}"/>
              </a:ext>
            </a:extLst>
          </p:cNvPr>
          <p:cNvSpPr txBox="1"/>
          <p:nvPr/>
        </p:nvSpPr>
        <p:spPr>
          <a:xfrm>
            <a:off x="5702835" y="7754045"/>
            <a:ext cx="1071346" cy="769441"/>
          </a:xfrm>
          <a:prstGeom prst="rect">
            <a:avLst/>
          </a:prstGeom>
          <a:noFill/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Follow-up </a:t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  <a:b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kumimoji="1" lang="en-US" altLang="ja-JP" sz="11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100" b="0" i="0" u="none" strike="noStrike" kern="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ays </a:t>
            </a: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8–21</a:t>
            </a:r>
          </a:p>
        </p:txBody>
      </p: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xmlns="" id="{664F5193-9D3E-4E07-B401-92EEB9F96039}"/>
              </a:ext>
            </a:extLst>
          </p:cNvPr>
          <p:cNvCxnSpPr>
            <a:cxnSpLocks/>
          </p:cNvCxnSpPr>
          <p:nvPr/>
        </p:nvCxnSpPr>
        <p:spPr>
          <a:xfrm>
            <a:off x="1906716" y="8381804"/>
            <a:ext cx="580580" cy="4503"/>
          </a:xfrm>
          <a:prstGeom prst="straightConnector1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sp>
        <p:nvSpPr>
          <p:cNvPr id="76" name="TextBox 75">
            <a:extLst>
              <a:ext uri="{FF2B5EF4-FFF2-40B4-BE49-F238E27FC236}">
                <a16:creationId xmlns:a16="http://schemas.microsoft.com/office/drawing/2014/main" xmlns="" id="{A3FAA98C-B8FB-41EC-ADDC-2236C82B8007}"/>
              </a:ext>
            </a:extLst>
          </p:cNvPr>
          <p:cNvSpPr txBox="1"/>
          <p:nvPr/>
        </p:nvSpPr>
        <p:spPr>
          <a:xfrm>
            <a:off x="1857674" y="7995323"/>
            <a:ext cx="692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ay 2–3</a:t>
            </a:r>
            <a:br>
              <a:rPr kumimoji="1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Washout</a:t>
            </a:r>
            <a:endParaRPr kumimoji="1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xmlns="" id="{75163ABA-E06C-44F3-BB1F-9556CBB1596F}"/>
              </a:ext>
            </a:extLst>
          </p:cNvPr>
          <p:cNvCxnSpPr>
            <a:cxnSpLocks/>
          </p:cNvCxnSpPr>
          <p:nvPr/>
        </p:nvCxnSpPr>
        <p:spPr>
          <a:xfrm>
            <a:off x="3730716" y="8381804"/>
            <a:ext cx="565301" cy="0"/>
          </a:xfrm>
          <a:prstGeom prst="straightConnector1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  <a:tailEnd type="triangle"/>
          </a:ln>
          <a:effectLst/>
        </p:spPr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74B8E39C-E0C7-484C-985E-C9BBFE3FA7AB}"/>
              </a:ext>
            </a:extLst>
          </p:cNvPr>
          <p:cNvSpPr txBox="1"/>
          <p:nvPr/>
        </p:nvSpPr>
        <p:spPr>
          <a:xfrm>
            <a:off x="3676206" y="7995323"/>
            <a:ext cx="692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ay </a:t>
            </a:r>
            <a:r>
              <a:rPr kumimoji="1" lang="en-US" altLang="ja-JP" sz="9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5–6</a:t>
            </a:r>
            <a:r>
              <a:rPr kumimoji="1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/>
            </a:r>
            <a:br>
              <a:rPr kumimoji="1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9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Washout</a:t>
            </a:r>
            <a:endParaRPr kumimoji="1" lang="ja-JP" altLang="en-US" sz="9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xmlns="" id="{5042BFCC-1287-4CB8-9AA8-5FC8F4463A7A}"/>
              </a:ext>
            </a:extLst>
          </p:cNvPr>
          <p:cNvCxnSpPr>
            <a:cxnSpLocks/>
          </p:cNvCxnSpPr>
          <p:nvPr/>
        </p:nvCxnSpPr>
        <p:spPr>
          <a:xfrm>
            <a:off x="2487296" y="8214966"/>
            <a:ext cx="1241854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xmlns="" id="{7DF0507B-A651-4B26-AE69-455D00243D6E}"/>
              </a:ext>
            </a:extLst>
          </p:cNvPr>
          <p:cNvCxnSpPr>
            <a:cxnSpLocks/>
          </p:cNvCxnSpPr>
          <p:nvPr/>
        </p:nvCxnSpPr>
        <p:spPr>
          <a:xfrm>
            <a:off x="739140" y="8211861"/>
            <a:ext cx="117940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xmlns="" id="{F49DA04C-CBDB-4AA4-8285-A3F675A28025}"/>
              </a:ext>
            </a:extLst>
          </p:cNvPr>
          <p:cNvCxnSpPr>
            <a:cxnSpLocks/>
          </p:cNvCxnSpPr>
          <p:nvPr/>
        </p:nvCxnSpPr>
        <p:spPr>
          <a:xfrm>
            <a:off x="4313705" y="8214966"/>
            <a:ext cx="1315885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82" name="Straight Connector 81">
            <a:extLst>
              <a:ext uri="{FF2B5EF4-FFF2-40B4-BE49-F238E27FC236}">
                <a16:creationId xmlns:a16="http://schemas.microsoft.com/office/drawing/2014/main" xmlns="" id="{350479BA-D15A-4A9F-BC58-AAA7F7CC75C5}"/>
              </a:ext>
            </a:extLst>
          </p:cNvPr>
          <p:cNvCxnSpPr>
            <a:cxnSpLocks/>
          </p:cNvCxnSpPr>
          <p:nvPr/>
        </p:nvCxnSpPr>
        <p:spPr>
          <a:xfrm>
            <a:off x="5702835" y="8214966"/>
            <a:ext cx="1071346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83" name="TextBox 82">
            <a:extLst>
              <a:ext uri="{FF2B5EF4-FFF2-40B4-BE49-F238E27FC236}">
                <a16:creationId xmlns:a16="http://schemas.microsoft.com/office/drawing/2014/main" xmlns="" id="{58325A1D-26E2-482F-AEAC-C7905BD2C0A4}"/>
              </a:ext>
            </a:extLst>
          </p:cNvPr>
          <p:cNvSpPr txBox="1"/>
          <p:nvPr/>
        </p:nvSpPr>
        <p:spPr>
          <a:xfrm>
            <a:off x="329470" y="7374742"/>
            <a:ext cx="19869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eriod in each step</a:t>
            </a:r>
            <a:endParaRPr kumimoji="1" lang="ja-JP" alt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8" name="Group 167">
            <a:extLst>
              <a:ext uri="{FF2B5EF4-FFF2-40B4-BE49-F238E27FC236}">
                <a16:creationId xmlns:a16="http://schemas.microsoft.com/office/drawing/2014/main" xmlns="" id="{553F8FFF-17C2-4A4E-B427-A2A59F6A4616}"/>
              </a:ext>
            </a:extLst>
          </p:cNvPr>
          <p:cNvGrpSpPr/>
          <p:nvPr/>
        </p:nvGrpSpPr>
        <p:grpSpPr>
          <a:xfrm>
            <a:off x="721022" y="9168172"/>
            <a:ext cx="4908568" cy="165577"/>
            <a:chOff x="-1544062" y="10569308"/>
            <a:chExt cx="9215696" cy="291549"/>
          </a:xfrm>
        </p:grpSpPr>
        <p:cxnSp>
          <p:nvCxnSpPr>
            <p:cNvPr id="84" name="Straight Connector 83">
              <a:extLst>
                <a:ext uri="{FF2B5EF4-FFF2-40B4-BE49-F238E27FC236}">
                  <a16:creationId xmlns:a16="http://schemas.microsoft.com/office/drawing/2014/main" xmlns="" id="{B1B91EF2-346E-4AB9-A3F2-2D0CAC567F8D}"/>
                </a:ext>
              </a:extLst>
            </p:cNvPr>
            <p:cNvCxnSpPr/>
            <p:nvPr/>
          </p:nvCxnSpPr>
          <p:spPr>
            <a:xfrm>
              <a:off x="-1544062" y="10569308"/>
              <a:ext cx="0" cy="291548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xmlns="" id="{3BC3BA86-7671-4B3B-B60F-885755525B2B}"/>
                </a:ext>
              </a:extLst>
            </p:cNvPr>
            <p:cNvCxnSpPr>
              <a:cxnSpLocks/>
            </p:cNvCxnSpPr>
            <p:nvPr/>
          </p:nvCxnSpPr>
          <p:spPr>
            <a:xfrm>
              <a:off x="-1544062" y="10860857"/>
              <a:ext cx="921026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86" name="Straight Connector 85">
              <a:extLst>
                <a:ext uri="{FF2B5EF4-FFF2-40B4-BE49-F238E27FC236}">
                  <a16:creationId xmlns:a16="http://schemas.microsoft.com/office/drawing/2014/main" xmlns="" id="{AD76987D-C771-4995-A1D9-579165B5A201}"/>
                </a:ext>
              </a:extLst>
            </p:cNvPr>
            <p:cNvCxnSpPr/>
            <p:nvPr/>
          </p:nvCxnSpPr>
          <p:spPr>
            <a:xfrm>
              <a:off x="7671634" y="10569308"/>
              <a:ext cx="0" cy="291548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  <p:sp>
        <p:nvSpPr>
          <p:cNvPr id="87" name="TextBox 86">
            <a:extLst>
              <a:ext uri="{FF2B5EF4-FFF2-40B4-BE49-F238E27FC236}">
                <a16:creationId xmlns:a16="http://schemas.microsoft.com/office/drawing/2014/main" xmlns="" id="{27B73AC0-93CA-4938-B5F2-1B2109D5F926}"/>
              </a:ext>
            </a:extLst>
          </p:cNvPr>
          <p:cNvSpPr txBox="1"/>
          <p:nvPr/>
        </p:nvSpPr>
        <p:spPr>
          <a:xfrm>
            <a:off x="2403531" y="9323958"/>
            <a:ext cx="14127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Hospitalization</a:t>
            </a:r>
            <a:endParaRPr kumimoji="1" lang="ja-JP" alt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xmlns="" id="{7562BCA8-2818-45F3-995B-EA9BAEA79D0D}"/>
              </a:ext>
            </a:extLst>
          </p:cNvPr>
          <p:cNvSpPr txBox="1"/>
          <p:nvPr/>
        </p:nvSpPr>
        <p:spPr>
          <a:xfrm>
            <a:off x="1918540" y="5227604"/>
            <a:ext cx="9337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tep M1</a:t>
            </a:r>
            <a:endParaRPr kumimoji="1" lang="ja-JP" alt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xmlns="" id="{0CDFA269-9040-4115-9250-EBF84AAD17DB}"/>
              </a:ext>
            </a:extLst>
          </p:cNvPr>
          <p:cNvSpPr txBox="1"/>
          <p:nvPr/>
        </p:nvSpPr>
        <p:spPr>
          <a:xfrm>
            <a:off x="3219440" y="5227604"/>
            <a:ext cx="9337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tep M2</a:t>
            </a:r>
            <a:endParaRPr kumimoji="1" lang="ja-JP" alt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xmlns="" id="{B3D3BC8B-91A6-471B-AC23-E99DE84B8ABF}"/>
              </a:ext>
            </a:extLst>
          </p:cNvPr>
          <p:cNvSpPr txBox="1"/>
          <p:nvPr/>
        </p:nvSpPr>
        <p:spPr>
          <a:xfrm>
            <a:off x="4514548" y="5227604"/>
            <a:ext cx="93375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tep M3</a:t>
            </a:r>
            <a:endParaRPr kumimoji="1" lang="ja-JP" alt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xmlns="" id="{D7C68F23-39D4-489E-8738-8ADAB905F3A6}"/>
              </a:ext>
            </a:extLst>
          </p:cNvPr>
          <p:cNvSpPr txBox="1"/>
          <p:nvPr/>
        </p:nvSpPr>
        <p:spPr>
          <a:xfrm>
            <a:off x="1812887" y="6308357"/>
            <a:ext cx="1248181" cy="261610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00 mg</a:t>
            </a:r>
            <a:endParaRPr kumimoji="1" lang="ja-JP" alt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xmlns="" id="{FD28E0A5-753C-4FB2-BBB6-ED997395CDA2}"/>
              </a:ext>
            </a:extLst>
          </p:cNvPr>
          <p:cNvSpPr txBox="1"/>
          <p:nvPr/>
        </p:nvSpPr>
        <p:spPr>
          <a:xfrm>
            <a:off x="3106675" y="5914568"/>
            <a:ext cx="1248181" cy="261610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00 mg</a:t>
            </a:r>
            <a:endParaRPr kumimoji="1" lang="ja-JP" alt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xmlns="" id="{BF7E4178-505A-4666-823F-87D3A323FB2C}"/>
              </a:ext>
            </a:extLst>
          </p:cNvPr>
          <p:cNvSpPr txBox="1"/>
          <p:nvPr/>
        </p:nvSpPr>
        <p:spPr>
          <a:xfrm>
            <a:off x="4389030" y="5579341"/>
            <a:ext cx="1248181" cy="261610"/>
          </a:xfrm>
          <a:prstGeom prst="rect">
            <a:avLst/>
          </a:prstGeom>
          <a:solidFill>
            <a:sysClr val="window" lastClr="FFFFFF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400 mg</a:t>
            </a:r>
            <a:endParaRPr kumimoji="1" lang="ja-JP" alt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xmlns="" id="{E01E128A-6D42-4E9C-8325-D7C0387996A9}"/>
              </a:ext>
            </a:extLst>
          </p:cNvPr>
          <p:cNvSpPr txBox="1"/>
          <p:nvPr/>
        </p:nvSpPr>
        <p:spPr>
          <a:xfrm>
            <a:off x="1754516" y="6930196"/>
            <a:ext cx="3890206" cy="261610"/>
          </a:xfrm>
          <a:prstGeom prst="rect">
            <a:avLst/>
          </a:prstGeom>
          <a:solidFill>
            <a:sysClr val="window" lastClr="FFFFFF"/>
          </a:solidFill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iscussion with physician for the next step</a:t>
            </a:r>
            <a:endParaRPr kumimoji="1" lang="ja-JP" alt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xmlns="" id="{E354153D-84BD-42E9-B4FD-FD40F78ABA2B}"/>
              </a:ext>
            </a:extLst>
          </p:cNvPr>
          <p:cNvSpPr txBox="1"/>
          <p:nvPr/>
        </p:nvSpPr>
        <p:spPr>
          <a:xfrm>
            <a:off x="1664228" y="6572984"/>
            <a:ext cx="14376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AC-302 9 participants</a:t>
            </a:r>
            <a:b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lacebo  3 participants</a:t>
            </a:r>
            <a:b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endParaRPr kumimoji="1" lang="ja-JP" altLang="en-US" sz="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xmlns="" id="{EF7B2CE8-2A0C-427E-8626-A45F4DFAF74E}"/>
              </a:ext>
            </a:extLst>
          </p:cNvPr>
          <p:cNvSpPr txBox="1"/>
          <p:nvPr/>
        </p:nvSpPr>
        <p:spPr>
          <a:xfrm>
            <a:off x="2966216" y="6185243"/>
            <a:ext cx="14376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AC-302 9 participants</a:t>
            </a:r>
            <a:b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lacebo  3 participants</a:t>
            </a:r>
            <a:b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endParaRPr kumimoji="1" lang="ja-JP" altLang="en-US" sz="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xmlns="" id="{657AB287-BF66-482F-B572-C05806503608}"/>
              </a:ext>
            </a:extLst>
          </p:cNvPr>
          <p:cNvSpPr txBox="1"/>
          <p:nvPr/>
        </p:nvSpPr>
        <p:spPr>
          <a:xfrm>
            <a:off x="4290383" y="5854112"/>
            <a:ext cx="14376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TAC-302 9 participants</a:t>
            </a:r>
            <a:b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Placebo  3 participants</a:t>
            </a:r>
            <a:br>
              <a:rPr kumimoji="1" lang="en-US" altLang="ja-JP" sz="8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</a:br>
            <a:endParaRPr kumimoji="1" lang="ja-JP" altLang="en-US" sz="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46" name="Group 145">
            <a:extLst>
              <a:ext uri="{FF2B5EF4-FFF2-40B4-BE49-F238E27FC236}">
                <a16:creationId xmlns:a16="http://schemas.microsoft.com/office/drawing/2014/main" xmlns="" id="{B7C5D7D5-563B-453B-B3E7-A20ECD0962F0}"/>
              </a:ext>
            </a:extLst>
          </p:cNvPr>
          <p:cNvGrpSpPr/>
          <p:nvPr/>
        </p:nvGrpSpPr>
        <p:grpSpPr>
          <a:xfrm>
            <a:off x="1749497" y="5839773"/>
            <a:ext cx="3900243" cy="730577"/>
            <a:chOff x="1779977" y="6451197"/>
            <a:chExt cx="3900243" cy="730577"/>
          </a:xfrm>
        </p:grpSpPr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xmlns="" id="{AC145AE2-ACF1-42B5-B761-75AF66108A3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33740" y="6788550"/>
              <a:ext cx="0" cy="38921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xmlns="" id="{3E67D50A-66BC-40B9-933C-9AB4034D0885}"/>
                </a:ext>
              </a:extLst>
            </p:cNvPr>
            <p:cNvCxnSpPr/>
            <p:nvPr/>
          </p:nvCxnSpPr>
          <p:spPr>
            <a:xfrm>
              <a:off x="3133740" y="6791868"/>
              <a:ext cx="127324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xmlns="" id="{625B97E5-7E87-4F3E-896D-D642899BC7F6}"/>
                </a:ext>
              </a:extLst>
            </p:cNvPr>
            <p:cNvCxnSpPr/>
            <p:nvPr/>
          </p:nvCxnSpPr>
          <p:spPr>
            <a:xfrm flipV="1">
              <a:off x="4406980" y="6451197"/>
              <a:ext cx="0" cy="340671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02" name="Straight Connector 101">
              <a:extLst>
                <a:ext uri="{FF2B5EF4-FFF2-40B4-BE49-F238E27FC236}">
                  <a16:creationId xmlns:a16="http://schemas.microsoft.com/office/drawing/2014/main" xmlns="" id="{67320BA6-909D-4DDA-8957-720D8EA69F51}"/>
                </a:ext>
              </a:extLst>
            </p:cNvPr>
            <p:cNvCxnSpPr/>
            <p:nvPr/>
          </p:nvCxnSpPr>
          <p:spPr>
            <a:xfrm>
              <a:off x="4406980" y="6451197"/>
              <a:ext cx="127324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03" name="Straight Connector 102">
              <a:extLst>
                <a:ext uri="{FF2B5EF4-FFF2-40B4-BE49-F238E27FC236}">
                  <a16:creationId xmlns:a16="http://schemas.microsoft.com/office/drawing/2014/main" xmlns="" id="{9CE1237A-61F4-4822-A696-642E6DBA90D1}"/>
                </a:ext>
              </a:extLst>
            </p:cNvPr>
            <p:cNvCxnSpPr>
              <a:cxnSpLocks/>
            </p:cNvCxnSpPr>
            <p:nvPr/>
          </p:nvCxnSpPr>
          <p:spPr>
            <a:xfrm>
              <a:off x="1779977" y="7181774"/>
              <a:ext cx="1356933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  <p:sp>
        <p:nvSpPr>
          <p:cNvPr id="104" name="Arrow: Right 103">
            <a:extLst>
              <a:ext uri="{FF2B5EF4-FFF2-40B4-BE49-F238E27FC236}">
                <a16:creationId xmlns:a16="http://schemas.microsoft.com/office/drawing/2014/main" xmlns="" id="{89768907-CCF6-4B9F-8705-A5B815150D7D}"/>
              </a:ext>
            </a:extLst>
          </p:cNvPr>
          <p:cNvSpPr/>
          <p:nvPr/>
        </p:nvSpPr>
        <p:spPr>
          <a:xfrm rot="16200000">
            <a:off x="4007030" y="6421773"/>
            <a:ext cx="740615" cy="270619"/>
          </a:xfrm>
          <a:prstGeom prst="rightArrow">
            <a:avLst/>
          </a:prstGeom>
          <a:solidFill>
            <a:srgbClr val="4472C4"/>
          </a:solidFill>
          <a:ln w="12700" cap="flat" cmpd="sng" algn="ctr">
            <a:solidFill>
              <a:srgbClr val="4472C4">
                <a:shade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105" name="Arrow: Right 104">
            <a:extLst>
              <a:ext uri="{FF2B5EF4-FFF2-40B4-BE49-F238E27FC236}">
                <a16:creationId xmlns:a16="http://schemas.microsoft.com/office/drawing/2014/main" xmlns="" id="{6160782F-6312-4CA3-A1E8-952883BD0072}"/>
              </a:ext>
            </a:extLst>
          </p:cNvPr>
          <p:cNvSpPr/>
          <p:nvPr/>
        </p:nvSpPr>
        <p:spPr>
          <a:xfrm rot="16200000">
            <a:off x="2927938" y="6609171"/>
            <a:ext cx="356290" cy="270618"/>
          </a:xfrm>
          <a:prstGeom prst="rightArrow">
            <a:avLst/>
          </a:prstGeom>
          <a:solidFill>
            <a:srgbClr val="4472C4"/>
          </a:solidFill>
          <a:ln w="12700" cap="flat" cmpd="sng" algn="ctr">
            <a:solidFill>
              <a:srgbClr val="4472C4">
                <a:shade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106" name="Oval 105">
            <a:extLst>
              <a:ext uri="{FF2B5EF4-FFF2-40B4-BE49-F238E27FC236}">
                <a16:creationId xmlns:a16="http://schemas.microsoft.com/office/drawing/2014/main" xmlns="" id="{E987DA5E-101B-4197-8C44-EC909A83D2FA}"/>
              </a:ext>
            </a:extLst>
          </p:cNvPr>
          <p:cNvSpPr/>
          <p:nvPr/>
        </p:nvSpPr>
        <p:spPr>
          <a:xfrm>
            <a:off x="1987272" y="5209630"/>
            <a:ext cx="787436" cy="300798"/>
          </a:xfrm>
          <a:prstGeom prst="ellips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107" name="Oval 106">
            <a:extLst>
              <a:ext uri="{FF2B5EF4-FFF2-40B4-BE49-F238E27FC236}">
                <a16:creationId xmlns:a16="http://schemas.microsoft.com/office/drawing/2014/main" xmlns="" id="{5A23AD9E-E76A-4BD8-8614-DA7F1E515143}"/>
              </a:ext>
            </a:extLst>
          </p:cNvPr>
          <p:cNvSpPr/>
          <p:nvPr/>
        </p:nvSpPr>
        <p:spPr>
          <a:xfrm>
            <a:off x="3285968" y="5209630"/>
            <a:ext cx="787436" cy="300798"/>
          </a:xfrm>
          <a:prstGeom prst="ellips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108" name="Oval 107">
            <a:extLst>
              <a:ext uri="{FF2B5EF4-FFF2-40B4-BE49-F238E27FC236}">
                <a16:creationId xmlns:a16="http://schemas.microsoft.com/office/drawing/2014/main" xmlns="" id="{9C2BC88F-EDCA-4F6B-9EE2-7BEFFFE0811F}"/>
              </a:ext>
            </a:extLst>
          </p:cNvPr>
          <p:cNvSpPr/>
          <p:nvPr/>
        </p:nvSpPr>
        <p:spPr>
          <a:xfrm>
            <a:off x="4584665" y="5209630"/>
            <a:ext cx="787436" cy="300798"/>
          </a:xfrm>
          <a:prstGeom prst="ellips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  <p:grpSp>
        <p:nvGrpSpPr>
          <p:cNvPr id="110" name="Group 109">
            <a:extLst>
              <a:ext uri="{FF2B5EF4-FFF2-40B4-BE49-F238E27FC236}">
                <a16:creationId xmlns:a16="http://schemas.microsoft.com/office/drawing/2014/main" xmlns="" id="{B52C1CC5-6B03-409E-9986-D749B680BEAC}"/>
              </a:ext>
            </a:extLst>
          </p:cNvPr>
          <p:cNvGrpSpPr/>
          <p:nvPr/>
        </p:nvGrpSpPr>
        <p:grpSpPr>
          <a:xfrm>
            <a:off x="1754516" y="2481494"/>
            <a:ext cx="3900243" cy="1654702"/>
            <a:chOff x="2858081" y="4461174"/>
            <a:chExt cx="7328033" cy="1654702"/>
          </a:xfrm>
        </p:grpSpPr>
        <p:grpSp>
          <p:nvGrpSpPr>
            <p:cNvPr id="111" name="Group 110">
              <a:extLst>
                <a:ext uri="{FF2B5EF4-FFF2-40B4-BE49-F238E27FC236}">
                  <a16:creationId xmlns:a16="http://schemas.microsoft.com/office/drawing/2014/main" xmlns="" id="{15B1C490-E23A-4B95-8E37-F8C5BF450A0E}"/>
                </a:ext>
              </a:extLst>
            </p:cNvPr>
            <p:cNvGrpSpPr/>
            <p:nvPr/>
          </p:nvGrpSpPr>
          <p:grpSpPr>
            <a:xfrm>
              <a:off x="2858081" y="5710081"/>
              <a:ext cx="2885450" cy="404190"/>
              <a:chOff x="2871333" y="4186083"/>
              <a:chExt cx="2885450" cy="404190"/>
            </a:xfrm>
          </p:grpSpPr>
          <p:cxnSp>
            <p:nvCxnSpPr>
              <p:cNvPr id="119" name="Straight Connector 118">
                <a:extLst>
                  <a:ext uri="{FF2B5EF4-FFF2-40B4-BE49-F238E27FC236}">
                    <a16:creationId xmlns:a16="http://schemas.microsoft.com/office/drawing/2014/main" xmlns="" id="{CE08FC64-2B26-4492-9327-D032F2C1EFF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871333" y="4590273"/>
                <a:ext cx="1399558" cy="0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0" name="Straight Connector 119">
                <a:extLst>
                  <a:ext uri="{FF2B5EF4-FFF2-40B4-BE49-F238E27FC236}">
                    <a16:creationId xmlns:a16="http://schemas.microsoft.com/office/drawing/2014/main" xmlns="" id="{C8041423-C886-43C4-85BD-1780351C57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82687" y="4186083"/>
                <a:ext cx="1474096" cy="0"/>
              </a:xfrm>
              <a:prstGeom prst="line">
                <a:avLst/>
              </a:prstGeom>
              <a:noFill/>
              <a:ln w="63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</p:grp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xmlns="" id="{732961A4-DD4C-4D1A-9867-797B05AF2FFB}"/>
                </a:ext>
              </a:extLst>
            </p:cNvPr>
            <p:cNvCxnSpPr>
              <a:cxnSpLocks/>
            </p:cNvCxnSpPr>
            <p:nvPr/>
          </p:nvCxnSpPr>
          <p:spPr>
            <a:xfrm>
              <a:off x="5739764" y="5292639"/>
              <a:ext cx="1468130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xmlns="" id="{4BB1ED03-0583-4FA6-AEC6-FB4D179B4031}"/>
                </a:ext>
              </a:extLst>
            </p:cNvPr>
            <p:cNvCxnSpPr>
              <a:cxnSpLocks/>
            </p:cNvCxnSpPr>
            <p:nvPr/>
          </p:nvCxnSpPr>
          <p:spPr>
            <a:xfrm>
              <a:off x="7207894" y="4875194"/>
              <a:ext cx="1490872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xmlns="" id="{861A25C6-4BEE-4CB1-A1DB-5FF31100BAC7}"/>
                </a:ext>
              </a:extLst>
            </p:cNvPr>
            <p:cNvCxnSpPr>
              <a:cxnSpLocks/>
            </p:cNvCxnSpPr>
            <p:nvPr/>
          </p:nvCxnSpPr>
          <p:spPr>
            <a:xfrm>
              <a:off x="8698766" y="4461174"/>
              <a:ext cx="1487348" cy="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xmlns="" id="{EED324C4-E3D9-4879-B894-E8AACD01BF58}"/>
                </a:ext>
              </a:extLst>
            </p:cNvPr>
            <p:cNvCxnSpPr>
              <a:cxnSpLocks/>
            </p:cNvCxnSpPr>
            <p:nvPr/>
          </p:nvCxnSpPr>
          <p:spPr>
            <a:xfrm>
              <a:off x="4272386" y="5707733"/>
              <a:ext cx="0" cy="408143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xmlns="" id="{803F27F2-1802-48B0-A6DA-CFABE3BE910C}"/>
                </a:ext>
              </a:extLst>
            </p:cNvPr>
            <p:cNvCxnSpPr>
              <a:cxnSpLocks/>
            </p:cNvCxnSpPr>
            <p:nvPr/>
          </p:nvCxnSpPr>
          <p:spPr>
            <a:xfrm>
              <a:off x="5742091" y="5299590"/>
              <a:ext cx="0" cy="408143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xmlns="" id="{67DCBCFD-0FF5-4EEC-BE93-A53A7592DC79}"/>
                </a:ext>
              </a:extLst>
            </p:cNvPr>
            <p:cNvCxnSpPr>
              <a:cxnSpLocks/>
            </p:cNvCxnSpPr>
            <p:nvPr/>
          </p:nvCxnSpPr>
          <p:spPr>
            <a:xfrm>
              <a:off x="7210031" y="4875194"/>
              <a:ext cx="0" cy="417445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xmlns="" id="{8EFBDB1F-27E3-43E2-B9FE-9BBB2A4E63DD}"/>
                </a:ext>
              </a:extLst>
            </p:cNvPr>
            <p:cNvCxnSpPr>
              <a:cxnSpLocks/>
            </p:cNvCxnSpPr>
            <p:nvPr/>
          </p:nvCxnSpPr>
          <p:spPr>
            <a:xfrm>
              <a:off x="8702427" y="4461174"/>
              <a:ext cx="0" cy="414020"/>
            </a:xfrm>
            <a:prstGeom prst="line">
              <a:avLst/>
            </a:prstGeom>
            <a:noFill/>
            <a:ln w="63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  <p:sp>
        <p:nvSpPr>
          <p:cNvPr id="121" name="TextBox 120">
            <a:extLst>
              <a:ext uri="{FF2B5EF4-FFF2-40B4-BE49-F238E27FC236}">
                <a16:creationId xmlns:a16="http://schemas.microsoft.com/office/drawing/2014/main" xmlns="" id="{DCBE68F3-2C10-4D93-9B02-2B0E1FD7A88E}"/>
              </a:ext>
            </a:extLst>
          </p:cNvPr>
          <p:cNvSpPr txBox="1"/>
          <p:nvPr/>
        </p:nvSpPr>
        <p:spPr>
          <a:xfrm>
            <a:off x="4589052" y="2233443"/>
            <a:ext cx="143554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200 mg</a:t>
            </a:r>
            <a:endParaRPr kumimoji="1" lang="ja-JP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xmlns="" id="{46D8B45F-5DDC-4EF9-BABF-1C049709DD2F}"/>
              </a:ext>
            </a:extLst>
          </p:cNvPr>
          <p:cNvSpPr txBox="1"/>
          <p:nvPr/>
        </p:nvSpPr>
        <p:spPr>
          <a:xfrm>
            <a:off x="3998148" y="2662557"/>
            <a:ext cx="931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00 mg</a:t>
            </a:r>
            <a:endParaRPr kumimoji="1" lang="ja-JP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xmlns="" id="{0A990B8F-4EE7-4605-8D32-32254C273EBB}"/>
              </a:ext>
            </a:extLst>
          </p:cNvPr>
          <p:cNvSpPr txBox="1"/>
          <p:nvPr/>
        </p:nvSpPr>
        <p:spPr>
          <a:xfrm>
            <a:off x="3225474" y="3067772"/>
            <a:ext cx="931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 mg</a:t>
            </a:r>
            <a:endParaRPr kumimoji="1" lang="ja-JP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xmlns="" id="{FAA505FA-2E23-4920-B449-189A3E660641}"/>
              </a:ext>
            </a:extLst>
          </p:cNvPr>
          <p:cNvSpPr txBox="1"/>
          <p:nvPr/>
        </p:nvSpPr>
        <p:spPr>
          <a:xfrm>
            <a:off x="2445317" y="3483691"/>
            <a:ext cx="931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 mg</a:t>
            </a:r>
            <a:endParaRPr kumimoji="1" lang="ja-JP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xmlns="" id="{0EFE2FF6-DFD1-4D64-8721-0A22EB5CB3E3}"/>
              </a:ext>
            </a:extLst>
          </p:cNvPr>
          <p:cNvSpPr txBox="1"/>
          <p:nvPr/>
        </p:nvSpPr>
        <p:spPr>
          <a:xfrm>
            <a:off x="1661032" y="3885596"/>
            <a:ext cx="9318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 mg</a:t>
            </a:r>
            <a:endParaRPr kumimoji="1" lang="ja-JP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xmlns="" id="{15AEB24D-7A91-48F6-AFC0-5DEACB99371A}"/>
              </a:ext>
            </a:extLst>
          </p:cNvPr>
          <p:cNvSpPr txBox="1"/>
          <p:nvPr/>
        </p:nvSpPr>
        <p:spPr>
          <a:xfrm>
            <a:off x="4905280" y="2843311"/>
            <a:ext cx="8456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00 mg</a:t>
            </a:r>
            <a:endParaRPr kumimoji="1" lang="ja-JP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Straight Connector 126">
            <a:extLst>
              <a:ext uri="{FF2B5EF4-FFF2-40B4-BE49-F238E27FC236}">
                <a16:creationId xmlns:a16="http://schemas.microsoft.com/office/drawing/2014/main" xmlns="" id="{A8B64688-1F96-4C23-AEF5-AE588CDFAD12}"/>
              </a:ext>
            </a:extLst>
          </p:cNvPr>
          <p:cNvCxnSpPr>
            <a:cxnSpLocks/>
          </p:cNvCxnSpPr>
          <p:nvPr/>
        </p:nvCxnSpPr>
        <p:spPr>
          <a:xfrm>
            <a:off x="4960269" y="3089532"/>
            <a:ext cx="694490" cy="0"/>
          </a:xfrm>
          <a:prstGeom prst="line">
            <a:avLst/>
          </a:prstGeom>
          <a:noFill/>
          <a:ln w="635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128" name="Arrow: Right 127">
            <a:extLst>
              <a:ext uri="{FF2B5EF4-FFF2-40B4-BE49-F238E27FC236}">
                <a16:creationId xmlns:a16="http://schemas.microsoft.com/office/drawing/2014/main" xmlns="" id="{ABDB9168-AB2B-40B7-9E54-680695C6E842}"/>
              </a:ext>
            </a:extLst>
          </p:cNvPr>
          <p:cNvSpPr/>
          <p:nvPr/>
        </p:nvSpPr>
        <p:spPr>
          <a:xfrm rot="16200000">
            <a:off x="4179565" y="3433875"/>
            <a:ext cx="1370522" cy="295669"/>
          </a:xfrm>
          <a:prstGeom prst="rightArrow">
            <a:avLst/>
          </a:prstGeom>
          <a:solidFill>
            <a:srgbClr val="4472C4"/>
          </a:solidFill>
          <a:ln w="12700" cap="flat" cmpd="sng" algn="ctr">
            <a:solidFill>
              <a:srgbClr val="4472C4">
                <a:shade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129" name="Arrow: Right 128">
            <a:extLst>
              <a:ext uri="{FF2B5EF4-FFF2-40B4-BE49-F238E27FC236}">
                <a16:creationId xmlns:a16="http://schemas.microsoft.com/office/drawing/2014/main" xmlns="" id="{C2DC27D1-5CD6-4689-B31D-D3C2D2102A1C}"/>
              </a:ext>
            </a:extLst>
          </p:cNvPr>
          <p:cNvSpPr/>
          <p:nvPr/>
        </p:nvSpPr>
        <p:spPr>
          <a:xfrm rot="16200000">
            <a:off x="3596371" y="3643345"/>
            <a:ext cx="951802" cy="295670"/>
          </a:xfrm>
          <a:prstGeom prst="rightArrow">
            <a:avLst/>
          </a:prstGeom>
          <a:solidFill>
            <a:srgbClr val="4472C4"/>
          </a:solidFill>
          <a:ln w="12700" cap="flat" cmpd="sng" algn="ctr">
            <a:solidFill>
              <a:srgbClr val="4472C4">
                <a:shade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130" name="Arrow: Right 129">
            <a:extLst>
              <a:ext uri="{FF2B5EF4-FFF2-40B4-BE49-F238E27FC236}">
                <a16:creationId xmlns:a16="http://schemas.microsoft.com/office/drawing/2014/main" xmlns="" id="{45B1DCEF-FCA4-4732-AC3C-4369F535F112}"/>
              </a:ext>
            </a:extLst>
          </p:cNvPr>
          <p:cNvSpPr/>
          <p:nvPr/>
        </p:nvSpPr>
        <p:spPr>
          <a:xfrm rot="16200000">
            <a:off x="3028150" y="3852738"/>
            <a:ext cx="533016" cy="295670"/>
          </a:xfrm>
          <a:prstGeom prst="rightArrow">
            <a:avLst/>
          </a:prstGeom>
          <a:solidFill>
            <a:srgbClr val="4472C4"/>
          </a:solidFill>
          <a:ln w="12700" cap="flat" cmpd="sng" algn="ctr">
            <a:solidFill>
              <a:srgbClr val="4472C4">
                <a:shade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131" name="Arrow: Right 130">
            <a:extLst>
              <a:ext uri="{FF2B5EF4-FFF2-40B4-BE49-F238E27FC236}">
                <a16:creationId xmlns:a16="http://schemas.microsoft.com/office/drawing/2014/main" xmlns="" id="{C516FFAF-8A98-4B58-819D-89AB2A5119BB}"/>
              </a:ext>
            </a:extLst>
          </p:cNvPr>
          <p:cNvSpPr/>
          <p:nvPr/>
        </p:nvSpPr>
        <p:spPr>
          <a:xfrm rot="16200000">
            <a:off x="2447596" y="4058608"/>
            <a:ext cx="127500" cy="291321"/>
          </a:xfrm>
          <a:prstGeom prst="rightArrow">
            <a:avLst>
              <a:gd name="adj1" fmla="val 50000"/>
              <a:gd name="adj2" fmla="val 76147"/>
            </a:avLst>
          </a:prstGeom>
          <a:solidFill>
            <a:srgbClr val="4472C4"/>
          </a:solidFill>
          <a:ln w="12700" cap="flat" cmpd="sng" algn="ctr">
            <a:solidFill>
              <a:srgbClr val="4472C4">
                <a:shade val="50000"/>
              </a:srgbClr>
            </a:solidFill>
            <a:prstDash val="solid"/>
            <a:miter lim="800000"/>
          </a:ln>
          <a:effectLst/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100" b="0" i="0" u="none" strike="noStrike" kern="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34" charset="-128"/>
              <a:cs typeface="+mn-cs"/>
            </a:endParaRP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xmlns="" id="{2F55EC31-64E4-4262-B105-8DDF24BBA2E6}"/>
              </a:ext>
            </a:extLst>
          </p:cNvPr>
          <p:cNvSpPr txBox="1"/>
          <p:nvPr/>
        </p:nvSpPr>
        <p:spPr>
          <a:xfrm>
            <a:off x="1754516" y="4275115"/>
            <a:ext cx="3900243" cy="261610"/>
          </a:xfrm>
          <a:prstGeom prst="rect">
            <a:avLst/>
          </a:prstGeom>
          <a:noFill/>
          <a:ln>
            <a:solidFill>
              <a:sysClr val="windowText" lastClr="000000"/>
            </a:solidFill>
          </a:ln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Discussion with physician for next step</a:t>
            </a:r>
            <a:endParaRPr kumimoji="1" lang="ja-JP" altLang="en-US" sz="11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xmlns="" id="{57DDD99B-97B0-4C2E-886B-BAAE07AF7763}"/>
              </a:ext>
            </a:extLst>
          </p:cNvPr>
          <p:cNvSpPr txBox="1"/>
          <p:nvPr/>
        </p:nvSpPr>
        <p:spPr>
          <a:xfrm>
            <a:off x="4851872" y="3095489"/>
            <a:ext cx="100256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fter meal</a:t>
            </a:r>
            <a:endParaRPr kumimoji="1" lang="ja-JP" altLang="en-US" sz="10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34" name="Table 133">
            <a:extLst>
              <a:ext uri="{FF2B5EF4-FFF2-40B4-BE49-F238E27FC236}">
                <a16:creationId xmlns:a16="http://schemas.microsoft.com/office/drawing/2014/main" xmlns="" id="{C90735BA-9BB3-42B1-B1AD-DDACF9B655A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30048358"/>
              </p:ext>
            </p:extLst>
          </p:nvPr>
        </p:nvGraphicFramePr>
        <p:xfrm>
          <a:off x="868680" y="777753"/>
          <a:ext cx="4771467" cy="1212890"/>
        </p:xfrm>
        <a:graphic>
          <a:graphicData uri="http://schemas.openxmlformats.org/drawingml/2006/table">
            <a:tbl>
              <a:tblPr firstRow="1" bandRow="1"/>
              <a:tblGrid>
                <a:gridCol w="895257">
                  <a:extLst>
                    <a:ext uri="{9D8B030D-6E8A-4147-A177-3AD203B41FA5}">
                      <a16:colId xmlns:a16="http://schemas.microsoft.com/office/drawing/2014/main" xmlns="" val="2677313632"/>
                    </a:ext>
                  </a:extLst>
                </a:gridCol>
                <a:gridCol w="775242">
                  <a:extLst>
                    <a:ext uri="{9D8B030D-6E8A-4147-A177-3AD203B41FA5}">
                      <a16:colId xmlns:a16="http://schemas.microsoft.com/office/drawing/2014/main" xmlns="" val="1921634007"/>
                    </a:ext>
                  </a:extLst>
                </a:gridCol>
                <a:gridCol w="775242">
                  <a:extLst>
                    <a:ext uri="{9D8B030D-6E8A-4147-A177-3AD203B41FA5}">
                      <a16:colId xmlns:a16="http://schemas.microsoft.com/office/drawing/2014/main" xmlns="" val="2310916833"/>
                    </a:ext>
                  </a:extLst>
                </a:gridCol>
                <a:gridCol w="775242">
                  <a:extLst>
                    <a:ext uri="{9D8B030D-6E8A-4147-A177-3AD203B41FA5}">
                      <a16:colId xmlns:a16="http://schemas.microsoft.com/office/drawing/2014/main" xmlns="" val="580685635"/>
                    </a:ext>
                  </a:extLst>
                </a:gridCol>
                <a:gridCol w="775242">
                  <a:extLst>
                    <a:ext uri="{9D8B030D-6E8A-4147-A177-3AD203B41FA5}">
                      <a16:colId xmlns:a16="http://schemas.microsoft.com/office/drawing/2014/main" xmlns="" val="782805903"/>
                    </a:ext>
                  </a:extLst>
                </a:gridCol>
                <a:gridCol w="775242">
                  <a:extLst>
                    <a:ext uri="{9D8B030D-6E8A-4147-A177-3AD203B41FA5}">
                      <a16:colId xmlns:a16="http://schemas.microsoft.com/office/drawing/2014/main" xmlns="" val="3365902234"/>
                    </a:ext>
                  </a:extLst>
                </a:gridCol>
              </a:tblGrid>
              <a:tr h="228600">
                <a:tc rowSpan="2"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r>
                        <a:rPr kumimoji="1" lang="en-NZ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ticipants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p 1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p 2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p 3A*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p 4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p5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22057378"/>
                  </a:ext>
                </a:extLst>
              </a:tr>
              <a:tr h="228600"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NZ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ep 3B*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646479008"/>
                  </a:ext>
                </a:extLst>
              </a:tr>
              <a:tr h="354985"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C-302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 </a:t>
                      </a:r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× 2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64466711"/>
                  </a:ext>
                </a:extLst>
              </a:tr>
              <a:tr h="354985"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acebo</a:t>
                      </a:r>
                      <a:endParaRPr kumimoji="1" lang="ja-JP" altLang="en-US" sz="105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algn="ctr"/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1pPr>
                      <a:lvl2pPr marL="660380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2pPr>
                      <a:lvl3pPr marL="132075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3pPr>
                      <a:lvl4pPr marL="198113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4pPr>
                      <a:lvl5pPr marL="2641519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5pPr>
                      <a:lvl6pPr marL="330189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6pPr>
                      <a:lvl7pPr marL="396227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7pPr>
                      <a:lvl8pPr marL="4622658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8pPr>
                      <a:lvl9pPr marL="5283037" algn="l" defTabSz="1320759" rtl="0" eaLnBrk="1" latinLnBrk="0" hangingPunct="1">
                        <a:defRPr sz="2600" kern="1200">
                          <a:solidFill>
                            <a:schemeClr val="tx1"/>
                          </a:solidFill>
                          <a:latin typeface="游ゴシック" panose="020F0502020204030204"/>
                        </a:defRPr>
                      </a:lvl9pPr>
                    </a:lstStyle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5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 × 2</a:t>
                      </a:r>
                    </a:p>
                  </a:txBody>
                  <a:tcPr>
                    <a:lnL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ysClr val="windowText" lastClr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89495163"/>
                  </a:ext>
                </a:extLst>
              </a:tr>
            </a:tbl>
          </a:graphicData>
        </a:graphic>
      </p:graphicFrame>
      <p:sp>
        <p:nvSpPr>
          <p:cNvPr id="140" name="TextBox 139">
            <a:extLst>
              <a:ext uri="{FF2B5EF4-FFF2-40B4-BE49-F238E27FC236}">
                <a16:creationId xmlns:a16="http://schemas.microsoft.com/office/drawing/2014/main" xmlns="" id="{C95F88B5-9619-4791-91DC-7715D57A4BA4}"/>
              </a:ext>
            </a:extLst>
          </p:cNvPr>
          <p:cNvSpPr txBox="1"/>
          <p:nvPr/>
        </p:nvSpPr>
        <p:spPr>
          <a:xfrm>
            <a:off x="141814" y="63534"/>
            <a:ext cx="26447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kumimoji="1" lang="ja-JP" altLang="en-US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69" name="Group 168">
            <a:extLst>
              <a:ext uri="{FF2B5EF4-FFF2-40B4-BE49-F238E27FC236}">
                <a16:creationId xmlns:a16="http://schemas.microsoft.com/office/drawing/2014/main" xmlns="" id="{71C94BD5-A1C7-440F-BAAD-0CF5C0A3A377}"/>
              </a:ext>
            </a:extLst>
          </p:cNvPr>
          <p:cNvGrpSpPr/>
          <p:nvPr/>
        </p:nvGrpSpPr>
        <p:grpSpPr>
          <a:xfrm rot="5400000">
            <a:off x="-1419693" y="2567732"/>
            <a:ext cx="3772412" cy="165577"/>
            <a:chOff x="-1544062" y="10569308"/>
            <a:chExt cx="9215696" cy="291549"/>
          </a:xfrm>
        </p:grpSpPr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xmlns="" id="{50D8E83C-14A8-421A-B78A-B1CBB6C7D63C}"/>
                </a:ext>
              </a:extLst>
            </p:cNvPr>
            <p:cNvCxnSpPr/>
            <p:nvPr/>
          </p:nvCxnSpPr>
          <p:spPr>
            <a:xfrm>
              <a:off x="-1544062" y="10569308"/>
              <a:ext cx="0" cy="291548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xmlns="" id="{8DAF6B6C-1CD3-4106-8285-4A239737C97B}"/>
                </a:ext>
              </a:extLst>
            </p:cNvPr>
            <p:cNvCxnSpPr>
              <a:cxnSpLocks/>
            </p:cNvCxnSpPr>
            <p:nvPr/>
          </p:nvCxnSpPr>
          <p:spPr>
            <a:xfrm>
              <a:off x="-1544062" y="10860857"/>
              <a:ext cx="921026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72" name="Straight Connector 171">
              <a:extLst>
                <a:ext uri="{FF2B5EF4-FFF2-40B4-BE49-F238E27FC236}">
                  <a16:creationId xmlns:a16="http://schemas.microsoft.com/office/drawing/2014/main" xmlns="" id="{C49C8A44-8116-4E89-AE4F-21052F48B2BC}"/>
                </a:ext>
              </a:extLst>
            </p:cNvPr>
            <p:cNvCxnSpPr/>
            <p:nvPr/>
          </p:nvCxnSpPr>
          <p:spPr>
            <a:xfrm>
              <a:off x="7671634" y="10569308"/>
              <a:ext cx="0" cy="291548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  <p:grpSp>
        <p:nvGrpSpPr>
          <p:cNvPr id="173" name="Group 172">
            <a:extLst>
              <a:ext uri="{FF2B5EF4-FFF2-40B4-BE49-F238E27FC236}">
                <a16:creationId xmlns:a16="http://schemas.microsoft.com/office/drawing/2014/main" xmlns="" id="{47CF4F8E-ED16-42A3-A34E-BF67DA00AFFE}"/>
              </a:ext>
            </a:extLst>
          </p:cNvPr>
          <p:cNvGrpSpPr/>
          <p:nvPr/>
        </p:nvGrpSpPr>
        <p:grpSpPr>
          <a:xfrm rot="5400000">
            <a:off x="-1595548" y="7188901"/>
            <a:ext cx="4124119" cy="165577"/>
            <a:chOff x="-1544062" y="10569308"/>
            <a:chExt cx="9215696" cy="291549"/>
          </a:xfrm>
        </p:grpSpPr>
        <p:cxnSp>
          <p:nvCxnSpPr>
            <p:cNvPr id="174" name="Straight Connector 173">
              <a:extLst>
                <a:ext uri="{FF2B5EF4-FFF2-40B4-BE49-F238E27FC236}">
                  <a16:creationId xmlns:a16="http://schemas.microsoft.com/office/drawing/2014/main" xmlns="" id="{A4249C8C-E57E-4D42-A298-A2608D1B383F}"/>
                </a:ext>
              </a:extLst>
            </p:cNvPr>
            <p:cNvCxnSpPr/>
            <p:nvPr/>
          </p:nvCxnSpPr>
          <p:spPr>
            <a:xfrm>
              <a:off x="-1544062" y="10569308"/>
              <a:ext cx="0" cy="291548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75" name="Straight Connector 174">
              <a:extLst>
                <a:ext uri="{FF2B5EF4-FFF2-40B4-BE49-F238E27FC236}">
                  <a16:creationId xmlns:a16="http://schemas.microsoft.com/office/drawing/2014/main" xmlns="" id="{54DA95A5-38CB-40EE-A319-4B8B5D8C5E56}"/>
                </a:ext>
              </a:extLst>
            </p:cNvPr>
            <p:cNvCxnSpPr>
              <a:cxnSpLocks/>
            </p:cNvCxnSpPr>
            <p:nvPr/>
          </p:nvCxnSpPr>
          <p:spPr>
            <a:xfrm>
              <a:off x="-1544062" y="10860857"/>
              <a:ext cx="921026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cxnSp>
          <p:nvCxnSpPr>
            <p:cNvPr id="176" name="Straight Connector 175">
              <a:extLst>
                <a:ext uri="{FF2B5EF4-FFF2-40B4-BE49-F238E27FC236}">
                  <a16:creationId xmlns:a16="http://schemas.microsoft.com/office/drawing/2014/main" xmlns="" id="{5961C72E-05BB-4218-A045-30501C338B3D}"/>
                </a:ext>
              </a:extLst>
            </p:cNvPr>
            <p:cNvCxnSpPr/>
            <p:nvPr/>
          </p:nvCxnSpPr>
          <p:spPr>
            <a:xfrm>
              <a:off x="7671634" y="10569308"/>
              <a:ext cx="0" cy="291548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</p:grpSp>
      <p:sp>
        <p:nvSpPr>
          <p:cNvPr id="177" name="TextBox 176">
            <a:extLst>
              <a:ext uri="{FF2B5EF4-FFF2-40B4-BE49-F238E27FC236}">
                <a16:creationId xmlns:a16="http://schemas.microsoft.com/office/drawing/2014/main" xmlns="" id="{7C51F5D2-6B21-449B-A2AD-09727EF4DF38}"/>
              </a:ext>
            </a:extLst>
          </p:cNvPr>
          <p:cNvSpPr txBox="1"/>
          <p:nvPr/>
        </p:nvSpPr>
        <p:spPr>
          <a:xfrm rot="16200000">
            <a:off x="-461505" y="2433694"/>
            <a:ext cx="14127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Single-dose study</a:t>
            </a:r>
            <a:endParaRPr kumimoji="1" lang="ja-JP" altLang="en-US" sz="11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xmlns="" id="{88103C79-3758-48D5-B621-6AA7941E5AFA}"/>
              </a:ext>
            </a:extLst>
          </p:cNvPr>
          <p:cNvSpPr txBox="1"/>
          <p:nvPr/>
        </p:nvSpPr>
        <p:spPr>
          <a:xfrm rot="16200000">
            <a:off x="-554789" y="7172887"/>
            <a:ext cx="159772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1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Multiple-dose study</a:t>
            </a:r>
            <a:endParaRPr kumimoji="1" lang="ja-JP" altLang="en-US" sz="1100" b="1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775995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2</TotalTime>
  <Words>102</Words>
  <Application>Microsoft Office PowerPoint</Application>
  <PresentationFormat>A4 210 x 297 mm</PresentationFormat>
  <Paragraphs>4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Arial</vt:lpstr>
      <vt:lpstr>Calibri</vt:lpstr>
      <vt:lpstr>Calibri Light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dical Writer</dc:creator>
  <cp:lastModifiedBy>Nishida Erika(西田 絵里香)</cp:lastModifiedBy>
  <cp:revision>8</cp:revision>
  <dcterms:created xsi:type="dcterms:W3CDTF">2019-11-12T22:20:36Z</dcterms:created>
  <dcterms:modified xsi:type="dcterms:W3CDTF">2020-01-08T06:31:27Z</dcterms:modified>
</cp:coreProperties>
</file>